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337" r:id="rId2"/>
  </p:sldIdLst>
  <p:sldSz cx="7772400" cy="10058400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4" userDrawn="1">
          <p15:clr>
            <a:srgbClr val="A4A3A4"/>
          </p15:clr>
        </p15:guide>
        <p15:guide id="2" pos="210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Prof. L Birkholtz" initials="PLB [5]" lastIdx="1" clrIdx="6">
    <p:extLst/>
  </p:cmAuthor>
  <p:cmAuthor id="1" name="Riette Van Biljon" initials="RVB" lastIdx="1" clrIdx="0">
    <p:extLst/>
  </p:cmAuthor>
  <p:cmAuthor id="8" name="Prof. L Birkholtz" initials="PLB [6]" lastIdx="1" clrIdx="7">
    <p:extLst/>
  </p:cmAuthor>
  <p:cmAuthor id="2" name="Riëtte" initials="R" lastIdx="1" clrIdx="1">
    <p:extLst/>
  </p:cmAuthor>
  <p:cmAuthor id="9" name="Riëtte Van Biljon" initials="RVB" lastIdx="3" clrIdx="8">
    <p:extLst/>
  </p:cmAuthor>
  <p:cmAuthor id="3" name="Prof. L Birkholtz" initials="PLB" lastIdx="1" clrIdx="2">
    <p:extLst/>
  </p:cmAuthor>
  <p:cmAuthor id="4" name="Prof. L Birkholtz" initials="PLB [2]" lastIdx="1" clrIdx="3">
    <p:extLst/>
  </p:cmAuthor>
  <p:cmAuthor id="5" name="Prof. L Birkholtz" initials="PLB [3]" lastIdx="1" clrIdx="4">
    <p:extLst/>
  </p:cmAuthor>
  <p:cmAuthor id="6" name="Prof. L Birkholtz" initials="PLB [4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6D9F1"/>
    <a:srgbClr val="17375E"/>
    <a:srgbClr val="376092"/>
    <a:srgbClr val="4BACC6"/>
    <a:srgbClr val="558ED5"/>
    <a:srgbClr val="E6E6E6"/>
    <a:srgbClr val="BFBFBF"/>
    <a:srgbClr val="2E75B6"/>
    <a:srgbClr val="3F2E56"/>
    <a:srgbClr val="581D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2980" autoAdjust="0"/>
    <p:restoredTop sz="96374" autoAdjust="0"/>
  </p:normalViewPr>
  <p:slideViewPr>
    <p:cSldViewPr snapToGrid="0">
      <p:cViewPr varScale="1">
        <p:scale>
          <a:sx n="65" d="100"/>
          <a:sy n="65" d="100"/>
        </p:scale>
        <p:origin x="2368" y="224"/>
      </p:cViewPr>
      <p:guideLst>
        <p:guide orient="horz" pos="1444"/>
        <p:guide pos="210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Ri&#235;tte\Documents\PhD%202015_2018\Penn%20State\2018\stages%20riette%20experiment%20(version%20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Ri&#235;tte\Documents\PhD%202015_2018\Penn%20State\2018\stages%20riette%20experiment%20(version%20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ndard"/>
        <c:varyColors val="0"/>
        <c:ser>
          <c:idx val="0"/>
          <c:order val="0"/>
          <c:tx>
            <c:strRef>
              <c:f>Graph!$G$21</c:f>
              <c:strCache>
                <c:ptCount val="1"/>
                <c:pt idx="0">
                  <c:v>R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G$22:$G$37</c:f>
              <c:numCache>
                <c:formatCode>0</c:formatCode>
                <c:ptCount val="16"/>
                <c:pt idx="0">
                  <c:v>32.258064516129032</c:v>
                </c:pt>
                <c:pt idx="1">
                  <c:v>76.31578947368422</c:v>
                </c:pt>
                <c:pt idx="2">
                  <c:v>44.881889763779526</c:v>
                </c:pt>
                <c:pt idx="3">
                  <c:v>66.666666666666657</c:v>
                </c:pt>
                <c:pt idx="4">
                  <c:v>40</c:v>
                </c:pt>
                <c:pt idx="5">
                  <c:v>16.45569620253164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EB-47F9-9275-E43A224C3543}"/>
            </c:ext>
          </c:extLst>
        </c:ser>
        <c:ser>
          <c:idx val="1"/>
          <c:order val="1"/>
          <c:tx>
            <c:strRef>
              <c:f>Graph!$H$21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BFBFBF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H$22:$H$37</c:f>
              <c:numCache>
                <c:formatCode>0</c:formatCode>
                <c:ptCount val="16"/>
                <c:pt idx="0">
                  <c:v>67.741935483870961</c:v>
                </c:pt>
                <c:pt idx="1">
                  <c:v>23.684210526315788</c:v>
                </c:pt>
                <c:pt idx="2">
                  <c:v>53.543307086614178</c:v>
                </c:pt>
                <c:pt idx="3">
                  <c:v>32.258064516129032</c:v>
                </c:pt>
                <c:pt idx="4">
                  <c:v>42.222222222222221</c:v>
                </c:pt>
                <c:pt idx="5">
                  <c:v>22.784810126582279</c:v>
                </c:pt>
                <c:pt idx="6">
                  <c:v>6.153846153846154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EB-47F9-9275-E43A224C3543}"/>
            </c:ext>
          </c:extLst>
        </c:ser>
        <c:ser>
          <c:idx val="2"/>
          <c:order val="2"/>
          <c:tx>
            <c:strRef>
              <c:f>Graph!$I$21</c:f>
              <c:strCache>
                <c:ptCount val="1"/>
                <c:pt idx="0">
                  <c:v>II</c:v>
                </c:pt>
              </c:strCache>
            </c:strRef>
          </c:tx>
          <c:spPr>
            <a:solidFill>
              <a:srgbClr val="558ED5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I$22:$I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1.39240506329114</c:v>
                </c:pt>
                <c:pt idx="5">
                  <c:v>20.253164556962027</c:v>
                </c:pt>
                <c:pt idx="6">
                  <c:v>50.769230769230766</c:v>
                </c:pt>
                <c:pt idx="7">
                  <c:v>63</c:v>
                </c:pt>
                <c:pt idx="8">
                  <c:v>21.875</c:v>
                </c:pt>
                <c:pt idx="9">
                  <c:v>10</c:v>
                </c:pt>
                <c:pt idx="10">
                  <c:v>6.481481481481481</c:v>
                </c:pt>
                <c:pt idx="11">
                  <c:v>5.7142857142857144</c:v>
                </c:pt>
                <c:pt idx="12">
                  <c:v>4.4943820224719104</c:v>
                </c:pt>
                <c:pt idx="13">
                  <c:v>3.1914893617021276</c:v>
                </c:pt>
                <c:pt idx="14">
                  <c:v>1.9607843137254901</c:v>
                </c:pt>
                <c:pt idx="15">
                  <c:v>4.65116279069767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EB-47F9-9275-E43A224C3543}"/>
            </c:ext>
          </c:extLst>
        </c:ser>
        <c:ser>
          <c:idx val="3"/>
          <c:order val="3"/>
          <c:tx>
            <c:strRef>
              <c:f>Graph!$J$21</c:f>
              <c:strCache>
                <c:ptCount val="1"/>
                <c:pt idx="0">
                  <c:v>IV</c:v>
                </c:pt>
              </c:strCache>
            </c:strRef>
          </c:tx>
          <c:spPr>
            <a:solidFill>
              <a:srgbClr val="376092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J$22:$J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3.958333333333336</c:v>
                </c:pt>
                <c:pt idx="9">
                  <c:v>38</c:v>
                </c:pt>
                <c:pt idx="10">
                  <c:v>56.481481481481474</c:v>
                </c:pt>
                <c:pt idx="11">
                  <c:v>55.238095238095241</c:v>
                </c:pt>
                <c:pt idx="12">
                  <c:v>51.68539325842697</c:v>
                </c:pt>
                <c:pt idx="13">
                  <c:v>48.936170212765958</c:v>
                </c:pt>
                <c:pt idx="14">
                  <c:v>36.274509803921568</c:v>
                </c:pt>
                <c:pt idx="15">
                  <c:v>25.5813953488372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BEB-47F9-9275-E43A224C3543}"/>
            </c:ext>
          </c:extLst>
        </c:ser>
        <c:ser>
          <c:idx val="4"/>
          <c:order val="4"/>
          <c:tx>
            <c:strRef>
              <c:f>Graph!$K$21</c:f>
              <c:strCache>
                <c:ptCount val="1"/>
                <c:pt idx="0">
                  <c:v>III</c:v>
                </c:pt>
              </c:strCache>
            </c:strRef>
          </c:tx>
          <c:spPr>
            <a:solidFill>
              <a:srgbClr val="4BACC6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K$22:$K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79746835443038</c:v>
                </c:pt>
                <c:pt idx="5">
                  <c:v>15.18987341772152</c:v>
                </c:pt>
                <c:pt idx="6">
                  <c:v>18.461538461538463</c:v>
                </c:pt>
                <c:pt idx="7">
                  <c:v>16</c:v>
                </c:pt>
                <c:pt idx="8">
                  <c:v>48.958333333333329</c:v>
                </c:pt>
                <c:pt idx="9">
                  <c:v>40</c:v>
                </c:pt>
                <c:pt idx="10">
                  <c:v>29.629629629629626</c:v>
                </c:pt>
                <c:pt idx="11">
                  <c:v>23.809523809523807</c:v>
                </c:pt>
                <c:pt idx="12">
                  <c:v>21.348314606741571</c:v>
                </c:pt>
                <c:pt idx="13">
                  <c:v>19.148936170212767</c:v>
                </c:pt>
                <c:pt idx="14">
                  <c:v>14.705882352941178</c:v>
                </c:pt>
                <c:pt idx="15">
                  <c:v>8.1395348837209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BEB-47F9-9275-E43A224C3543}"/>
            </c:ext>
          </c:extLst>
        </c:ser>
        <c:ser>
          <c:idx val="5"/>
          <c:order val="5"/>
          <c:tx>
            <c:strRef>
              <c:f>Graph!$L$21</c:f>
              <c:strCache>
                <c:ptCount val="1"/>
                <c:pt idx="0">
                  <c:v>V</c:v>
                </c:pt>
              </c:strCache>
            </c:strRef>
          </c:tx>
          <c:spPr>
            <a:solidFill>
              <a:srgbClr val="17375E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L$22:$L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083333333333333</c:v>
                </c:pt>
                <c:pt idx="9">
                  <c:v>11</c:v>
                </c:pt>
                <c:pt idx="10">
                  <c:v>6.481481481481481</c:v>
                </c:pt>
                <c:pt idx="11">
                  <c:v>13.333333333333334</c:v>
                </c:pt>
                <c:pt idx="12">
                  <c:v>22.471910112359549</c:v>
                </c:pt>
                <c:pt idx="13">
                  <c:v>28.723404255319153</c:v>
                </c:pt>
                <c:pt idx="14">
                  <c:v>47.058823529411761</c:v>
                </c:pt>
                <c:pt idx="15">
                  <c:v>61.627906976744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BEB-47F9-9275-E43A224C3543}"/>
            </c:ext>
          </c:extLst>
        </c:ser>
        <c:ser>
          <c:idx val="6"/>
          <c:order val="6"/>
          <c:tx>
            <c:strRef>
              <c:f>Graph!$M$21</c:f>
              <c:strCache>
                <c:ptCount val="1"/>
                <c:pt idx="0">
                  <c:v>I</c:v>
                </c:pt>
              </c:strCache>
            </c:strRef>
          </c:tx>
          <c:spPr>
            <a:solidFill>
              <a:srgbClr val="C6D9F1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M$22:$M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1.5748031496062991</c:v>
                </c:pt>
                <c:pt idx="3">
                  <c:v>1.1235955056179776</c:v>
                </c:pt>
                <c:pt idx="4">
                  <c:v>9</c:v>
                </c:pt>
                <c:pt idx="5">
                  <c:v>25.316455696202532</c:v>
                </c:pt>
                <c:pt idx="6">
                  <c:v>24.615384615384617</c:v>
                </c:pt>
                <c:pt idx="7">
                  <c:v>21</c:v>
                </c:pt>
                <c:pt idx="8">
                  <c:v>3.125</c:v>
                </c:pt>
                <c:pt idx="9">
                  <c:v>1</c:v>
                </c:pt>
                <c:pt idx="10">
                  <c:v>0.92592592592592582</c:v>
                </c:pt>
                <c:pt idx="11">
                  <c:v>1.904761904761904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BEB-47F9-9275-E43A224C35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3319040"/>
        <c:axId val="1223316416"/>
      </c:areaChart>
      <c:catAx>
        <c:axId val="12233190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23316416"/>
        <c:crosses val="autoZero"/>
        <c:auto val="1"/>
        <c:lblAlgn val="ctr"/>
        <c:lblOffset val="100"/>
        <c:noMultiLvlLbl val="0"/>
      </c:catAx>
      <c:valAx>
        <c:axId val="1223316416"/>
        <c:scaling>
          <c:orientation val="minMax"/>
          <c:max val="80"/>
          <c:min val="0"/>
        </c:scaling>
        <c:delete val="1"/>
        <c:axPos val="l"/>
        <c:numFmt formatCode="0" sourceLinked="1"/>
        <c:majorTickMark val="out"/>
        <c:minorTickMark val="none"/>
        <c:tickLblPos val="nextTo"/>
        <c:crossAx val="1223319040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areaChart>
        <c:grouping val="standard"/>
        <c:varyColors val="0"/>
        <c:ser>
          <c:idx val="0"/>
          <c:order val="0"/>
          <c:tx>
            <c:strRef>
              <c:f>Graph!$G$21</c:f>
              <c:strCache>
                <c:ptCount val="1"/>
                <c:pt idx="0">
                  <c:v>R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G$22:$G$37</c:f>
              <c:numCache>
                <c:formatCode>0</c:formatCode>
                <c:ptCount val="16"/>
                <c:pt idx="0">
                  <c:v>32.258064516129032</c:v>
                </c:pt>
                <c:pt idx="1">
                  <c:v>76.31578947368422</c:v>
                </c:pt>
                <c:pt idx="2">
                  <c:v>44.881889763779526</c:v>
                </c:pt>
                <c:pt idx="3">
                  <c:v>66.666666666666657</c:v>
                </c:pt>
                <c:pt idx="4">
                  <c:v>40</c:v>
                </c:pt>
                <c:pt idx="5">
                  <c:v>16.45569620253164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C4-4D81-8529-F01B3A599B14}"/>
            </c:ext>
          </c:extLst>
        </c:ser>
        <c:ser>
          <c:idx val="1"/>
          <c:order val="1"/>
          <c:tx>
            <c:strRef>
              <c:f>Graph!$H$21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BFBFBF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H$22:$H$37</c:f>
              <c:numCache>
                <c:formatCode>0</c:formatCode>
                <c:ptCount val="16"/>
                <c:pt idx="0">
                  <c:v>67.741935483870961</c:v>
                </c:pt>
                <c:pt idx="1">
                  <c:v>23.684210526315788</c:v>
                </c:pt>
                <c:pt idx="2">
                  <c:v>53.543307086614178</c:v>
                </c:pt>
                <c:pt idx="3">
                  <c:v>32.258064516129032</c:v>
                </c:pt>
                <c:pt idx="4">
                  <c:v>42.222222222222221</c:v>
                </c:pt>
                <c:pt idx="5">
                  <c:v>22.784810126582279</c:v>
                </c:pt>
                <c:pt idx="6">
                  <c:v>6.153846153846154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C4-4D81-8529-F01B3A599B14}"/>
            </c:ext>
          </c:extLst>
        </c:ser>
        <c:ser>
          <c:idx val="2"/>
          <c:order val="2"/>
          <c:tx>
            <c:strRef>
              <c:f>Graph!$I$21</c:f>
              <c:strCache>
                <c:ptCount val="1"/>
                <c:pt idx="0">
                  <c:v>II</c:v>
                </c:pt>
              </c:strCache>
            </c:strRef>
          </c:tx>
          <c:spPr>
            <a:solidFill>
              <a:srgbClr val="558ED5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I$22:$I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1.39240506329114</c:v>
                </c:pt>
                <c:pt idx="5">
                  <c:v>20.253164556962027</c:v>
                </c:pt>
                <c:pt idx="6">
                  <c:v>50.769230769230766</c:v>
                </c:pt>
                <c:pt idx="7">
                  <c:v>63</c:v>
                </c:pt>
                <c:pt idx="8">
                  <c:v>21.875</c:v>
                </c:pt>
                <c:pt idx="9">
                  <c:v>10</c:v>
                </c:pt>
                <c:pt idx="10">
                  <c:v>6.481481481481481</c:v>
                </c:pt>
                <c:pt idx="11">
                  <c:v>5.7142857142857144</c:v>
                </c:pt>
                <c:pt idx="12">
                  <c:v>4.4943820224719104</c:v>
                </c:pt>
                <c:pt idx="13">
                  <c:v>3.1914893617021276</c:v>
                </c:pt>
                <c:pt idx="14">
                  <c:v>1.9607843137254901</c:v>
                </c:pt>
                <c:pt idx="15">
                  <c:v>4.65116279069767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CC4-4D81-8529-F01B3A599B14}"/>
            </c:ext>
          </c:extLst>
        </c:ser>
        <c:ser>
          <c:idx val="3"/>
          <c:order val="3"/>
          <c:tx>
            <c:strRef>
              <c:f>Graph!$J$21</c:f>
              <c:strCache>
                <c:ptCount val="1"/>
                <c:pt idx="0">
                  <c:v>IV</c:v>
                </c:pt>
              </c:strCache>
            </c:strRef>
          </c:tx>
          <c:spPr>
            <a:solidFill>
              <a:srgbClr val="376092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J$22:$J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3.958333333333336</c:v>
                </c:pt>
                <c:pt idx="9">
                  <c:v>38</c:v>
                </c:pt>
                <c:pt idx="10">
                  <c:v>56.481481481481474</c:v>
                </c:pt>
                <c:pt idx="11">
                  <c:v>55.238095238095241</c:v>
                </c:pt>
                <c:pt idx="12">
                  <c:v>51.68539325842697</c:v>
                </c:pt>
                <c:pt idx="13">
                  <c:v>48.936170212765958</c:v>
                </c:pt>
                <c:pt idx="14">
                  <c:v>36.274509803921568</c:v>
                </c:pt>
                <c:pt idx="15">
                  <c:v>25.5813953488372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CC4-4D81-8529-F01B3A599B14}"/>
            </c:ext>
          </c:extLst>
        </c:ser>
        <c:ser>
          <c:idx val="4"/>
          <c:order val="4"/>
          <c:tx>
            <c:strRef>
              <c:f>Graph!$K$21</c:f>
              <c:strCache>
                <c:ptCount val="1"/>
                <c:pt idx="0">
                  <c:v>III</c:v>
                </c:pt>
              </c:strCache>
            </c:strRef>
          </c:tx>
          <c:spPr>
            <a:solidFill>
              <a:srgbClr val="4BACC6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K$22:$K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79746835443038</c:v>
                </c:pt>
                <c:pt idx="5">
                  <c:v>15.18987341772152</c:v>
                </c:pt>
                <c:pt idx="6">
                  <c:v>18.461538461538463</c:v>
                </c:pt>
                <c:pt idx="7">
                  <c:v>16</c:v>
                </c:pt>
                <c:pt idx="8">
                  <c:v>48.958333333333329</c:v>
                </c:pt>
                <c:pt idx="9">
                  <c:v>40</c:v>
                </c:pt>
                <c:pt idx="10">
                  <c:v>29.629629629629626</c:v>
                </c:pt>
                <c:pt idx="11">
                  <c:v>23.809523809523807</c:v>
                </c:pt>
                <c:pt idx="12">
                  <c:v>21.348314606741571</c:v>
                </c:pt>
                <c:pt idx="13">
                  <c:v>19.148936170212767</c:v>
                </c:pt>
                <c:pt idx="14">
                  <c:v>14.705882352941178</c:v>
                </c:pt>
                <c:pt idx="15">
                  <c:v>8.1395348837209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CC4-4D81-8529-F01B3A599B14}"/>
            </c:ext>
          </c:extLst>
        </c:ser>
        <c:ser>
          <c:idx val="5"/>
          <c:order val="5"/>
          <c:tx>
            <c:strRef>
              <c:f>Graph!$L$21</c:f>
              <c:strCache>
                <c:ptCount val="1"/>
                <c:pt idx="0">
                  <c:v>V</c:v>
                </c:pt>
              </c:strCache>
            </c:strRef>
          </c:tx>
          <c:spPr>
            <a:solidFill>
              <a:srgbClr val="17375E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L$22:$L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083333333333333</c:v>
                </c:pt>
                <c:pt idx="9">
                  <c:v>11</c:v>
                </c:pt>
                <c:pt idx="10">
                  <c:v>6.481481481481481</c:v>
                </c:pt>
                <c:pt idx="11">
                  <c:v>13.333333333333334</c:v>
                </c:pt>
                <c:pt idx="12">
                  <c:v>22.471910112359549</c:v>
                </c:pt>
                <c:pt idx="13">
                  <c:v>28.723404255319153</c:v>
                </c:pt>
                <c:pt idx="14">
                  <c:v>47.058823529411761</c:v>
                </c:pt>
                <c:pt idx="15">
                  <c:v>61.627906976744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CC4-4D81-8529-F01B3A599B14}"/>
            </c:ext>
          </c:extLst>
        </c:ser>
        <c:ser>
          <c:idx val="6"/>
          <c:order val="6"/>
          <c:tx>
            <c:strRef>
              <c:f>Graph!$M$21</c:f>
              <c:strCache>
                <c:ptCount val="1"/>
                <c:pt idx="0">
                  <c:v>I</c:v>
                </c:pt>
              </c:strCache>
            </c:strRef>
          </c:tx>
          <c:spPr>
            <a:solidFill>
              <a:srgbClr val="C6D9F1"/>
            </a:solidFill>
            <a:ln>
              <a:noFill/>
            </a:ln>
            <a:effectLst/>
          </c:spPr>
          <c:cat>
            <c:numRef>
              <c:f>Graph!$F$22:$F$37</c:f>
              <c:numCache>
                <c:formatCode>General</c:formatCode>
                <c:ptCount val="16"/>
                <c:pt idx="0">
                  <c:v>-2</c:v>
                </c:pt>
                <c:pt idx="1">
                  <c:v>-1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6</c:v>
                </c:pt>
                <c:pt idx="9">
                  <c:v>7</c:v>
                </c:pt>
                <c:pt idx="10">
                  <c:v>8</c:v>
                </c:pt>
                <c:pt idx="11">
                  <c:v>9</c:v>
                </c:pt>
                <c:pt idx="12">
                  <c:v>10</c:v>
                </c:pt>
                <c:pt idx="13">
                  <c:v>11</c:v>
                </c:pt>
                <c:pt idx="14">
                  <c:v>12</c:v>
                </c:pt>
                <c:pt idx="15">
                  <c:v>13</c:v>
                </c:pt>
              </c:numCache>
            </c:numRef>
          </c:cat>
          <c:val>
            <c:numRef>
              <c:f>Graph!$M$22:$M$37</c:f>
              <c:numCache>
                <c:formatCode>0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1.5748031496062991</c:v>
                </c:pt>
                <c:pt idx="3">
                  <c:v>1.1235955056179776</c:v>
                </c:pt>
                <c:pt idx="4">
                  <c:v>9</c:v>
                </c:pt>
                <c:pt idx="5">
                  <c:v>25.316455696202532</c:v>
                </c:pt>
                <c:pt idx="6">
                  <c:v>24.615384615384617</c:v>
                </c:pt>
                <c:pt idx="7">
                  <c:v>21</c:v>
                </c:pt>
                <c:pt idx="8">
                  <c:v>3.125</c:v>
                </c:pt>
                <c:pt idx="9">
                  <c:v>1</c:v>
                </c:pt>
                <c:pt idx="10">
                  <c:v>0.92592592592592582</c:v>
                </c:pt>
                <c:pt idx="11">
                  <c:v>1.904761904761904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CC4-4D81-8529-F01B3A599B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3319040"/>
        <c:axId val="1223316416"/>
      </c:areaChart>
      <c:catAx>
        <c:axId val="12233190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23316416"/>
        <c:crosses val="autoZero"/>
        <c:auto val="1"/>
        <c:lblAlgn val="ctr"/>
        <c:lblOffset val="100"/>
        <c:noMultiLvlLbl val="0"/>
      </c:catAx>
      <c:valAx>
        <c:axId val="1223316416"/>
        <c:scaling>
          <c:orientation val="minMax"/>
          <c:max val="80"/>
          <c:min val="0"/>
        </c:scaling>
        <c:delete val="1"/>
        <c:axPos val="l"/>
        <c:numFmt formatCode="0" sourceLinked="1"/>
        <c:majorTickMark val="out"/>
        <c:minorTickMark val="none"/>
        <c:tickLblPos val="nextTo"/>
        <c:crossAx val="1223319040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7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7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119" cy="466434"/>
          </a:xfrm>
          <a:prstGeom prst="rect">
            <a:avLst/>
          </a:prstGeom>
        </p:spPr>
        <p:txBody>
          <a:bodyPr vert="horz" lIns="92444" tIns="46222" rIns="92444" bIns="46222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3" y="0"/>
            <a:ext cx="2982119" cy="466434"/>
          </a:xfrm>
          <a:prstGeom prst="rect">
            <a:avLst/>
          </a:prstGeom>
        </p:spPr>
        <p:txBody>
          <a:bodyPr vert="horz" lIns="92444" tIns="46222" rIns="92444" bIns="46222" rtlCol="0"/>
          <a:lstStyle>
            <a:lvl1pPr algn="r">
              <a:defRPr sz="1200"/>
            </a:lvl1pPr>
          </a:lstStyle>
          <a:p>
            <a:fld id="{41AAA729-676B-4536-9F1E-F238CA7BD85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0438" y="1162050"/>
            <a:ext cx="242093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4" tIns="46222" rIns="92444" bIns="46222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4" tIns="46222" rIns="92444" bIns="4622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8"/>
            <a:ext cx="2982119" cy="466433"/>
          </a:xfrm>
          <a:prstGeom prst="rect">
            <a:avLst/>
          </a:prstGeom>
        </p:spPr>
        <p:txBody>
          <a:bodyPr vert="horz" lIns="92444" tIns="46222" rIns="92444" bIns="46222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3" y="8829968"/>
            <a:ext cx="2982119" cy="466433"/>
          </a:xfrm>
          <a:prstGeom prst="rect">
            <a:avLst/>
          </a:prstGeom>
        </p:spPr>
        <p:txBody>
          <a:bodyPr vert="horz" lIns="92444" tIns="46222" rIns="92444" bIns="46222" rtlCol="0" anchor="b"/>
          <a:lstStyle>
            <a:lvl1pPr algn="r">
              <a:defRPr sz="1200"/>
            </a:lvl1pPr>
          </a:lstStyle>
          <a:p>
            <a:fld id="{A7D31F1E-AF26-463D-A9BA-9835807E9E08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3356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1pPr>
    <a:lvl2pPr marL="486225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2pPr>
    <a:lvl3pPr marL="972449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3pPr>
    <a:lvl4pPr marL="1458674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4pPr>
    <a:lvl5pPr marL="1944899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5pPr>
    <a:lvl6pPr marL="2431124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6pPr>
    <a:lvl7pPr marL="2917348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7pPr>
    <a:lvl8pPr marL="3403572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8pPr>
    <a:lvl9pPr marL="3889797" algn="l" defTabSz="972449" rtl="0" eaLnBrk="1" latinLnBrk="0" hangingPunct="1">
      <a:defRPr sz="127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28850" y="1162050"/>
            <a:ext cx="2424113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D31F1E-AF26-463D-A9BA-9835807E9E08}" type="slidenum">
              <a:rPr lang="en-ZA" smtClean="0"/>
              <a:pPr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43473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19" indent="0" algn="ctr">
              <a:buNone/>
              <a:defRPr sz="1701"/>
            </a:lvl2pPr>
            <a:lvl3pPr marL="777239" indent="0" algn="ctr">
              <a:buNone/>
              <a:defRPr sz="1530"/>
            </a:lvl3pPr>
            <a:lvl4pPr marL="1165857" indent="0" algn="ctr">
              <a:buNone/>
              <a:defRPr sz="1360"/>
            </a:lvl4pPr>
            <a:lvl5pPr marL="1554477" indent="0" algn="ctr">
              <a:buNone/>
              <a:defRPr sz="1360"/>
            </a:lvl5pPr>
            <a:lvl6pPr marL="1943096" indent="0" algn="ctr">
              <a:buNone/>
              <a:defRPr sz="1360"/>
            </a:lvl6pPr>
            <a:lvl7pPr marL="2331715" indent="0" algn="ctr">
              <a:buNone/>
              <a:defRPr sz="1360"/>
            </a:lvl7pPr>
            <a:lvl8pPr marL="2720335" indent="0" algn="ctr">
              <a:buNone/>
              <a:defRPr sz="1360"/>
            </a:lvl8pPr>
            <a:lvl9pPr marL="3108954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23412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35566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87595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7152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7" y="2507619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7" y="6731214"/>
            <a:ext cx="6703695" cy="2200275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19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2pPr>
            <a:lvl3pPr marL="777239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5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7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1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3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5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39307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5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5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754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7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8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19" indent="0">
              <a:buNone/>
              <a:defRPr sz="1701" b="1"/>
            </a:lvl2pPr>
            <a:lvl3pPr marL="777239" indent="0">
              <a:buNone/>
              <a:defRPr sz="1530" b="1"/>
            </a:lvl3pPr>
            <a:lvl4pPr marL="1165857" indent="0">
              <a:buNone/>
              <a:defRPr sz="1360" b="1"/>
            </a:lvl4pPr>
            <a:lvl5pPr marL="1554477" indent="0">
              <a:buNone/>
              <a:defRPr sz="1360" b="1"/>
            </a:lvl5pPr>
            <a:lvl6pPr marL="1943096" indent="0">
              <a:buNone/>
              <a:defRPr sz="1360" b="1"/>
            </a:lvl6pPr>
            <a:lvl7pPr marL="2331715" indent="0">
              <a:buNone/>
              <a:defRPr sz="1360" b="1"/>
            </a:lvl7pPr>
            <a:lvl8pPr marL="2720335" indent="0">
              <a:buNone/>
              <a:defRPr sz="1360" b="1"/>
            </a:lvl8pPr>
            <a:lvl9pPr marL="3108954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8" y="3674111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19" indent="0">
              <a:buNone/>
              <a:defRPr sz="1701" b="1"/>
            </a:lvl2pPr>
            <a:lvl3pPr marL="777239" indent="0">
              <a:buNone/>
              <a:defRPr sz="1530" b="1"/>
            </a:lvl3pPr>
            <a:lvl4pPr marL="1165857" indent="0">
              <a:buNone/>
              <a:defRPr sz="1360" b="1"/>
            </a:lvl4pPr>
            <a:lvl5pPr marL="1554477" indent="0">
              <a:buNone/>
              <a:defRPr sz="1360" b="1"/>
            </a:lvl5pPr>
            <a:lvl6pPr marL="1943096" indent="0">
              <a:buNone/>
              <a:defRPr sz="1360" b="1"/>
            </a:lvl6pPr>
            <a:lvl7pPr marL="2331715" indent="0">
              <a:buNone/>
              <a:defRPr sz="1360" b="1"/>
            </a:lvl7pPr>
            <a:lvl8pPr marL="2720335" indent="0">
              <a:buNone/>
              <a:defRPr sz="1360" b="1"/>
            </a:lvl8pPr>
            <a:lvl9pPr marL="3108954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1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20038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83796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38563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7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1"/>
            </a:lvl4pPr>
            <a:lvl5pPr>
              <a:defRPr sz="1701"/>
            </a:lvl5pPr>
            <a:lvl6pPr>
              <a:defRPr sz="1701"/>
            </a:lvl6pPr>
            <a:lvl7pPr>
              <a:defRPr sz="1701"/>
            </a:lvl7pPr>
            <a:lvl8pPr>
              <a:defRPr sz="1701"/>
            </a:lvl8pPr>
            <a:lvl9pPr>
              <a:defRPr sz="1701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7" y="3017521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19" indent="0">
              <a:buNone/>
              <a:defRPr sz="1190"/>
            </a:lvl2pPr>
            <a:lvl3pPr marL="777239" indent="0">
              <a:buNone/>
              <a:defRPr sz="1020"/>
            </a:lvl3pPr>
            <a:lvl4pPr marL="1165857" indent="0">
              <a:buNone/>
              <a:defRPr sz="850"/>
            </a:lvl4pPr>
            <a:lvl5pPr marL="1554477" indent="0">
              <a:buNone/>
              <a:defRPr sz="850"/>
            </a:lvl5pPr>
            <a:lvl6pPr marL="1943096" indent="0">
              <a:buNone/>
              <a:defRPr sz="850"/>
            </a:lvl6pPr>
            <a:lvl7pPr marL="2331715" indent="0">
              <a:buNone/>
              <a:defRPr sz="850"/>
            </a:lvl7pPr>
            <a:lvl8pPr marL="2720335" indent="0">
              <a:buNone/>
              <a:defRPr sz="850"/>
            </a:lvl8pPr>
            <a:lvl9pPr marL="3108954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78305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7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19" indent="0">
              <a:buNone/>
              <a:defRPr sz="2380"/>
            </a:lvl2pPr>
            <a:lvl3pPr marL="777239" indent="0">
              <a:buNone/>
              <a:defRPr sz="2040"/>
            </a:lvl3pPr>
            <a:lvl4pPr marL="1165857" indent="0">
              <a:buNone/>
              <a:defRPr sz="1701"/>
            </a:lvl4pPr>
            <a:lvl5pPr marL="1554477" indent="0">
              <a:buNone/>
              <a:defRPr sz="1701"/>
            </a:lvl5pPr>
            <a:lvl6pPr marL="1943096" indent="0">
              <a:buNone/>
              <a:defRPr sz="1701"/>
            </a:lvl6pPr>
            <a:lvl7pPr marL="2331715" indent="0">
              <a:buNone/>
              <a:defRPr sz="1701"/>
            </a:lvl7pPr>
            <a:lvl8pPr marL="2720335" indent="0">
              <a:buNone/>
              <a:defRPr sz="1701"/>
            </a:lvl8pPr>
            <a:lvl9pPr marL="3108954" indent="0">
              <a:buNone/>
              <a:defRPr sz="170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7" y="3017521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19" indent="0">
              <a:buNone/>
              <a:defRPr sz="1190"/>
            </a:lvl2pPr>
            <a:lvl3pPr marL="777239" indent="0">
              <a:buNone/>
              <a:defRPr sz="1020"/>
            </a:lvl3pPr>
            <a:lvl4pPr marL="1165857" indent="0">
              <a:buNone/>
              <a:defRPr sz="850"/>
            </a:lvl4pPr>
            <a:lvl5pPr marL="1554477" indent="0">
              <a:buNone/>
              <a:defRPr sz="850"/>
            </a:lvl5pPr>
            <a:lvl6pPr marL="1943096" indent="0">
              <a:buNone/>
              <a:defRPr sz="850"/>
            </a:lvl6pPr>
            <a:lvl7pPr marL="2331715" indent="0">
              <a:buNone/>
              <a:defRPr sz="850"/>
            </a:lvl7pPr>
            <a:lvl8pPr marL="2720335" indent="0">
              <a:buNone/>
              <a:defRPr sz="850"/>
            </a:lvl8pPr>
            <a:lvl9pPr marL="3108954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6055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5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5" y="2677585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6DA8A-9D13-47F7-B19A-E41D1CAAD2D0}" type="datetimeFigureOut">
              <a:rPr lang="en-ZA" smtClean="0"/>
              <a:pPr/>
              <a:t>2019/05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10" y="9322650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2A028-04CB-4B87-B944-F13638ECBFAB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5835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77239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39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29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47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360167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86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06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25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44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64" indent="-194310" algn="l" defTabSz="777239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19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39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57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77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96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15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35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54" algn="l" defTabSz="77723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1AF5D87-9447-4BE0-8AF5-BD47CDA454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49"/>
          <a:stretch/>
        </p:blipFill>
        <p:spPr>
          <a:xfrm>
            <a:off x="1006543" y="4993538"/>
            <a:ext cx="1510869" cy="991677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D0612BCF-90D6-4D73-AD0D-3873518849D5}"/>
              </a:ext>
            </a:extLst>
          </p:cNvPr>
          <p:cNvGrpSpPr/>
          <p:nvPr/>
        </p:nvGrpSpPr>
        <p:grpSpPr>
          <a:xfrm>
            <a:off x="489800" y="4797355"/>
            <a:ext cx="2950369" cy="1915212"/>
            <a:chOff x="83343" y="35258"/>
            <a:chExt cx="2950369" cy="191521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7CFA571D-0D08-42F7-B44F-1DBFA76340C4}"/>
                </a:ext>
              </a:extLst>
            </p:cNvPr>
            <p:cNvGrpSpPr/>
            <p:nvPr/>
          </p:nvGrpSpPr>
          <p:grpSpPr>
            <a:xfrm>
              <a:off x="325744" y="35258"/>
              <a:ext cx="1526409" cy="1330385"/>
              <a:chOff x="249822" y="-295061"/>
              <a:chExt cx="2409046" cy="189255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611E7CA-9944-4683-A413-405BBFA378A9}"/>
                  </a:ext>
                </a:extLst>
              </p:cNvPr>
              <p:cNvSpPr txBox="1"/>
              <p:nvPr/>
            </p:nvSpPr>
            <p:spPr>
              <a:xfrm>
                <a:off x="568473" y="1311988"/>
                <a:ext cx="2090395" cy="2855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ZA" sz="704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p2-g (pf3d7_1222600)</a:t>
                </a:r>
                <a:endParaRPr lang="en-US" sz="704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9CFFD50-148B-4846-90C8-63F102321786}"/>
                  </a:ext>
                </a:extLst>
              </p:cNvPr>
              <p:cNvSpPr txBox="1"/>
              <p:nvPr/>
            </p:nvSpPr>
            <p:spPr>
              <a:xfrm>
                <a:off x="249822" y="-295061"/>
                <a:ext cx="602509" cy="1828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200000"/>
                  </a:lnSpc>
                </a:pPr>
                <a:r>
                  <a:rPr lang="en-ZA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.0</a:t>
                </a:r>
              </a:p>
              <a:p>
                <a:pPr>
                  <a:lnSpc>
                    <a:spcPct val="200000"/>
                  </a:lnSpc>
                </a:pPr>
                <a:r>
                  <a:rPr lang="en-ZA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2.0</a:t>
                </a:r>
              </a:p>
              <a:p>
                <a:pPr>
                  <a:lnSpc>
                    <a:spcPct val="200000"/>
                  </a:lnSpc>
                </a:pPr>
                <a:r>
                  <a:rPr lang="en-ZA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1.0</a:t>
                </a:r>
              </a:p>
              <a:p>
                <a:pPr>
                  <a:lnSpc>
                    <a:spcPct val="200000"/>
                  </a:lnSpc>
                </a:pPr>
                <a:r>
                  <a:rPr lang="en-ZA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0</a:t>
                </a:r>
              </a:p>
              <a:p>
                <a:pPr>
                  <a:lnSpc>
                    <a:spcPct val="200000"/>
                  </a:lnSpc>
                </a:pPr>
                <a:r>
                  <a:rPr lang="en-ZA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.0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FC320AC-7321-4B5E-861E-FDEA3C4453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-3286" r="8157" b="12944"/>
            <a:stretch/>
          </p:blipFill>
          <p:spPr>
            <a:xfrm>
              <a:off x="1586404" y="258413"/>
              <a:ext cx="524551" cy="109538"/>
            </a:xfrm>
            <a:prstGeom prst="rect">
              <a:avLst/>
            </a:prstGeom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3A4C3DC-2A40-4D00-B014-5A9C4898E551}"/>
                </a:ext>
              </a:extLst>
            </p:cNvPr>
            <p:cNvSpPr/>
            <p:nvPr/>
          </p:nvSpPr>
          <p:spPr>
            <a:xfrm>
              <a:off x="600086" y="224600"/>
              <a:ext cx="1511893" cy="1116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B2351B7-84AE-4EA4-9B24-ABAAC63E11E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350442" y="201650"/>
              <a:ext cx="698" cy="151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983E64F-50FF-4220-B4C9-F5C204AA2987}"/>
                </a:ext>
              </a:extLst>
            </p:cNvPr>
            <p:cNvSpPr txBox="1"/>
            <p:nvPr/>
          </p:nvSpPr>
          <p:spPr>
            <a:xfrm>
              <a:off x="83343" y="1488805"/>
              <a:ext cx="2950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2 Fig. Transcript abundance of </a:t>
              </a:r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p2-g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line) and downstream genes (ribbon, identified in 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Josling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t al.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19) </a:t>
              </a:r>
            </a:p>
          </p:txBody>
        </p:sp>
      </p:grp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DCC29D9E-6C20-42F9-8D71-73BC34E40F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5118848"/>
              </p:ext>
            </p:extLst>
          </p:nvPr>
        </p:nvGraphicFramePr>
        <p:xfrm>
          <a:off x="763059" y="604823"/>
          <a:ext cx="2289697" cy="3548826"/>
        </p:xfrm>
        <a:graphic>
          <a:graphicData uri="http://schemas.openxmlformats.org/drawingml/2006/table">
            <a:tbl>
              <a:tblPr/>
              <a:tblGrid>
                <a:gridCol w="141007">
                  <a:extLst>
                    <a:ext uri="{9D8B030D-6E8A-4147-A177-3AD203B41FA5}">
                      <a16:colId xmlns:a16="http://schemas.microsoft.com/office/drawing/2014/main" val="434117869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2185632936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1171906589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3462501626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1050073246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4211852166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1574244793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19992079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2025060161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4069468111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4062329673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404419584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785563028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3144070711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2089709977"/>
                    </a:ext>
                  </a:extLst>
                </a:gridCol>
                <a:gridCol w="143246">
                  <a:extLst>
                    <a:ext uri="{9D8B030D-6E8A-4147-A177-3AD203B41FA5}">
                      <a16:colId xmlns:a16="http://schemas.microsoft.com/office/drawing/2014/main" val="2426770460"/>
                    </a:ext>
                  </a:extLst>
                </a:gridCol>
              </a:tblGrid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9E9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999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909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999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81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CF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C0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9487601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949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C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C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D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636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BE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CB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898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8779669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D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8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C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A2A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71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A3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868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8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4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9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D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3848007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3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0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A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2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A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D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9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8237661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E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AF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F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9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0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1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C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D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4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8C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C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A7A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D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4720327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4C4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5E5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545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76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6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6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4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3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4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5714237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9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C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3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3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BE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E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2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EE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0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D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A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4130280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9D9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2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C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6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EE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F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E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EE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9877046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3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D7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2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BF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D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C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1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0187815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E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8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8D8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B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1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4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8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CF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9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9466167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4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5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5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8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CB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8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2772878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0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F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BE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6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3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9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9D9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858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B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8F9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8F9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C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8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D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1840068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A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AF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4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4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79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A0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D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B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9422718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A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D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F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C7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1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4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B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0483876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C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959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D7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A2A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F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3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D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C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6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D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0234995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C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3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6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2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E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2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6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6226559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A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AEB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1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0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F9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5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6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9514353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A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1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0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A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6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7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0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347149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1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B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AF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2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D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CD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1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A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D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1085047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D2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EE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B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B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D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2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CD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9895053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D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4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E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C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9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7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1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D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4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4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2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7727960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4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9F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3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C9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5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4686736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E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9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C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0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2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D7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4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A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8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1408529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C7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CA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5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0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D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5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CB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7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9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B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162588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1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6C6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B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C3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D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4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6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A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C7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C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DD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3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CF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D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53450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959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B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8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7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5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A8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CA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1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C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3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2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7783322"/>
                  </a:ext>
                </a:extLst>
              </a:tr>
              <a:tr h="13143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A8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E7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CB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F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C0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8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88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6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B8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C9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2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B6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C7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C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54" marR="6554" marT="6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A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5175036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533EDBEF-4D91-4CAF-AE96-77FBBE8349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3079070"/>
              </p:ext>
            </p:extLst>
          </p:nvPr>
        </p:nvGraphicFramePr>
        <p:xfrm>
          <a:off x="-291043" y="614785"/>
          <a:ext cx="1054100" cy="3549015"/>
        </p:xfrm>
        <a:graphic>
          <a:graphicData uri="http://schemas.openxmlformats.org/drawingml/2006/table">
            <a:tbl>
              <a:tblPr/>
              <a:tblGrid>
                <a:gridCol w="1054100">
                  <a:extLst>
                    <a:ext uri="{9D8B030D-6E8A-4147-A177-3AD203B41FA5}">
                      <a16:colId xmlns:a16="http://schemas.microsoft.com/office/drawing/2014/main" val="1146235483"/>
                    </a:ext>
                  </a:extLst>
                </a:gridCol>
              </a:tblGrid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429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0470628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404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555760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3509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9296436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4495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390410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802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72679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2-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1861754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611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2108448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408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3970236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317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456811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2224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0110528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9344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8659127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5168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2571665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143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6983013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239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3707675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6138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4123448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305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3633661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3429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4118056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4560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9448066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4203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7826209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1078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7820504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1393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9088235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0077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9874044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1155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6215194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14664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1741502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6229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845357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604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922704"/>
                  </a:ext>
                </a:extLst>
              </a:tr>
              <a:tr h="125653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d7_07037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0345521"/>
                  </a:ext>
                </a:extLst>
              </a:tr>
            </a:tbl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966E72A9-FD29-4F5F-B31C-CCE24EA9FE79}"/>
              </a:ext>
            </a:extLst>
          </p:cNvPr>
          <p:cNvSpPr txBox="1"/>
          <p:nvPr/>
        </p:nvSpPr>
        <p:spPr>
          <a:xfrm>
            <a:off x="393700" y="4144127"/>
            <a:ext cx="2950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1 Fig. Transcript abundance of ApiAP2 transcription factors during 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. falciparum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ametocyte development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E8366170-F629-41DF-A355-65D085363AE0}"/>
              </a:ext>
            </a:extLst>
          </p:cNvPr>
          <p:cNvGrpSpPr/>
          <p:nvPr/>
        </p:nvGrpSpPr>
        <p:grpSpPr>
          <a:xfrm>
            <a:off x="632475" y="-1110"/>
            <a:ext cx="2548800" cy="743693"/>
            <a:chOff x="374514" y="3417347"/>
            <a:chExt cx="2768516" cy="743693"/>
          </a:xfrm>
        </p:grpSpPr>
        <p:graphicFrame>
          <p:nvGraphicFramePr>
            <p:cNvPr id="28" name="Chart 27">
              <a:extLst>
                <a:ext uri="{FF2B5EF4-FFF2-40B4-BE49-F238E27FC236}">
                  <a16:creationId xmlns:a16="http://schemas.microsoft.com/office/drawing/2014/main" id="{9850F2F9-0DB7-4C3C-B5C7-8F0A87A1390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6383296"/>
                </p:ext>
              </p:extLst>
            </p:nvPr>
          </p:nvGraphicFramePr>
          <p:xfrm>
            <a:off x="374514" y="3417347"/>
            <a:ext cx="2768516" cy="7436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95C865AD-3CA3-43D0-971A-DB74E6ECBEB6}"/>
                </a:ext>
              </a:extLst>
            </p:cNvPr>
            <p:cNvGrpSpPr/>
            <p:nvPr/>
          </p:nvGrpSpPr>
          <p:grpSpPr>
            <a:xfrm>
              <a:off x="396399" y="3590492"/>
              <a:ext cx="2662970" cy="487507"/>
              <a:chOff x="390912" y="3058041"/>
              <a:chExt cx="2662970" cy="487507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2586B930-39E1-442A-B790-BC6A3427A1E2}"/>
                  </a:ext>
                </a:extLst>
              </p:cNvPr>
              <p:cNvSpPr txBox="1"/>
              <p:nvPr/>
            </p:nvSpPr>
            <p:spPr>
              <a:xfrm>
                <a:off x="390912" y="3209357"/>
                <a:ext cx="372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C45923F-A2FB-4E1B-B669-194B0F50A371}"/>
                  </a:ext>
                </a:extLst>
              </p:cNvPr>
              <p:cNvSpPr txBox="1"/>
              <p:nvPr/>
            </p:nvSpPr>
            <p:spPr>
              <a:xfrm>
                <a:off x="1239621" y="3299327"/>
                <a:ext cx="2423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D21C5ABE-D3AA-4668-81D0-C0899A2A39F1}"/>
                  </a:ext>
                </a:extLst>
              </p:cNvPr>
              <p:cNvSpPr txBox="1"/>
              <p:nvPr/>
            </p:nvSpPr>
            <p:spPr>
              <a:xfrm>
                <a:off x="510644" y="3058041"/>
                <a:ext cx="372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F62367A-F2EC-462B-A573-88777B521140}"/>
                  </a:ext>
                </a:extLst>
              </p:cNvPr>
              <p:cNvSpPr txBox="1"/>
              <p:nvPr/>
            </p:nvSpPr>
            <p:spPr>
              <a:xfrm>
                <a:off x="1391094" y="3140983"/>
                <a:ext cx="3215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72BD6D5-63EF-4045-AA7A-BAB890A650ED}"/>
                  </a:ext>
                </a:extLst>
              </p:cNvPr>
              <p:cNvSpPr txBox="1"/>
              <p:nvPr/>
            </p:nvSpPr>
            <p:spPr>
              <a:xfrm>
                <a:off x="1686688" y="3214512"/>
                <a:ext cx="372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FFF12CB-2D49-4495-8568-451FE2B35A66}"/>
                  </a:ext>
                </a:extLst>
              </p:cNvPr>
              <p:cNvSpPr txBox="1"/>
              <p:nvPr/>
            </p:nvSpPr>
            <p:spPr>
              <a:xfrm>
                <a:off x="2032487" y="3121446"/>
                <a:ext cx="372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B999802-91BC-4B9A-873C-0EF55115AB26}"/>
                  </a:ext>
                </a:extLst>
              </p:cNvPr>
              <p:cNvSpPr txBox="1"/>
              <p:nvPr/>
            </p:nvSpPr>
            <p:spPr>
              <a:xfrm>
                <a:off x="2681858" y="3218296"/>
                <a:ext cx="372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endPara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8C285544-7296-4729-B783-6960DEBA3DF0}"/>
              </a:ext>
            </a:extLst>
          </p:cNvPr>
          <p:cNvGrpSpPr/>
          <p:nvPr/>
        </p:nvGrpSpPr>
        <p:grpSpPr>
          <a:xfrm>
            <a:off x="863457" y="4509653"/>
            <a:ext cx="1796399" cy="617711"/>
            <a:chOff x="374514" y="3417347"/>
            <a:chExt cx="2768516" cy="743693"/>
          </a:xfrm>
        </p:grpSpPr>
        <p:graphicFrame>
          <p:nvGraphicFramePr>
            <p:cNvPr id="39" name="Chart 38">
              <a:extLst>
                <a:ext uri="{FF2B5EF4-FFF2-40B4-BE49-F238E27FC236}">
                  <a16:creationId xmlns:a16="http://schemas.microsoft.com/office/drawing/2014/main" id="{77DE97B5-B3B1-4553-94E9-455E819F7D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3468919"/>
                </p:ext>
              </p:extLst>
            </p:nvPr>
          </p:nvGraphicFramePr>
          <p:xfrm>
            <a:off x="374514" y="3417347"/>
            <a:ext cx="2768516" cy="7436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B8CC9750-F217-4722-8490-3018F192884E}"/>
                </a:ext>
              </a:extLst>
            </p:cNvPr>
            <p:cNvGrpSpPr/>
            <p:nvPr/>
          </p:nvGrpSpPr>
          <p:grpSpPr>
            <a:xfrm>
              <a:off x="448679" y="3596276"/>
              <a:ext cx="2565984" cy="470959"/>
              <a:chOff x="443192" y="3063825"/>
              <a:chExt cx="2565984" cy="470959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2DDFB67-2C7C-44C1-89F0-0BC45B255A0E}"/>
                  </a:ext>
                </a:extLst>
              </p:cNvPr>
              <p:cNvSpPr txBox="1"/>
              <p:nvPr/>
            </p:nvSpPr>
            <p:spPr>
              <a:xfrm>
                <a:off x="1251724" y="3275401"/>
                <a:ext cx="242369" cy="2593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35547A8-E237-4544-A1E6-F8E637993CBD}"/>
                  </a:ext>
                </a:extLst>
              </p:cNvPr>
              <p:cNvSpPr txBox="1"/>
              <p:nvPr/>
            </p:nvSpPr>
            <p:spPr>
              <a:xfrm>
                <a:off x="443192" y="3167198"/>
                <a:ext cx="372024" cy="259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EA23E86-5545-4ADD-8114-ABEFE467B938}"/>
                  </a:ext>
                </a:extLst>
              </p:cNvPr>
              <p:cNvSpPr txBox="1"/>
              <p:nvPr/>
            </p:nvSpPr>
            <p:spPr>
              <a:xfrm>
                <a:off x="566075" y="3063825"/>
                <a:ext cx="372024" cy="2593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2025DDBC-C1F7-4580-A3ED-B3D772BA09E5}"/>
                  </a:ext>
                </a:extLst>
              </p:cNvPr>
              <p:cNvSpPr txBox="1"/>
              <p:nvPr/>
            </p:nvSpPr>
            <p:spPr>
              <a:xfrm>
                <a:off x="1376666" y="3142288"/>
                <a:ext cx="372022" cy="259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57855334-9569-4EB4-A719-4567C077D883}"/>
                  </a:ext>
                </a:extLst>
              </p:cNvPr>
              <p:cNvSpPr txBox="1"/>
              <p:nvPr/>
            </p:nvSpPr>
            <p:spPr>
              <a:xfrm>
                <a:off x="1648241" y="3203438"/>
                <a:ext cx="426133" cy="259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33CE327-1C47-4918-B6B6-3DE18985952B}"/>
                  </a:ext>
                </a:extLst>
              </p:cNvPr>
              <p:cNvSpPr txBox="1"/>
              <p:nvPr/>
            </p:nvSpPr>
            <p:spPr>
              <a:xfrm>
                <a:off x="1932293" y="3124615"/>
                <a:ext cx="552666" cy="259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B339E1A-D2A5-4422-A5F5-EBF970C730FD}"/>
                  </a:ext>
                </a:extLst>
              </p:cNvPr>
              <p:cNvSpPr txBox="1"/>
              <p:nvPr/>
            </p:nvSpPr>
            <p:spPr>
              <a:xfrm>
                <a:off x="2637152" y="3204727"/>
                <a:ext cx="372024" cy="259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9171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715</TotalTime>
  <Words>95</Words>
  <Application>Microsoft Macintosh PowerPoint</Application>
  <PresentationFormat>Custom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ette Van Biljon</dc:creator>
  <cp:lastModifiedBy>Prof. L Birkholtz</cp:lastModifiedBy>
  <cp:revision>1466</cp:revision>
  <cp:lastPrinted>2019-03-11T18:24:15Z</cp:lastPrinted>
  <dcterms:created xsi:type="dcterms:W3CDTF">2016-04-15T06:07:48Z</dcterms:created>
  <dcterms:modified xsi:type="dcterms:W3CDTF">2019-05-06T12:51:41Z</dcterms:modified>
</cp:coreProperties>
</file>